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0612"/>
  </p:normalViewPr>
  <p:slideViewPr>
    <p:cSldViewPr snapToGrid="0" snapToObjects="1">
      <p:cViewPr varScale="1">
        <p:scale>
          <a:sx n="84" d="100"/>
          <a:sy n="84" d="100"/>
        </p:scale>
        <p:origin x="20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1D63FC-076C-0D4A-9B52-6ACC09CCCD54}" type="datetimeFigureOut">
              <a:rPr lang="en-US" smtClean="0"/>
              <a:t>9/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2D7D77-C06A-9D4E-8CC7-C9CB57BB85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742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1. Time to progression (TTP) over time in patients with cross-sectional imaging prior to progression. </a:t>
            </a:r>
            <a:r>
              <a:rPr lang="en-US" dirty="0"/>
              <a:t>The TTP is presented stratified by the Mayo 2018 SMM risk score at baseline (n=496) (A), and post-diagnosis landmarks of 1 year (n=343) (B), 3 years (n=208) (C), and 4 years (n= 161) (D). The risk score was re-assessed based on updated data at each time point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BA48A4-5A21-0948-82FC-E7E928CB5E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498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200D1D-CD2C-EC45-B2D0-FAC0A153E9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14108B-9468-EF49-B7C7-687D8059BE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256CA8-BC24-9C49-83DA-8248BC70A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A723A-8749-864C-ABA5-D0D2B1A74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CFFC0-3F77-BB4D-860C-4F3BBF58A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823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31F66F-A4FB-0D41-BCB4-52A32C82C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AE11BE-C2B3-BF4A-8A43-E16F409048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35CA8-21F0-F643-8906-A0D829E9B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E82BE-276D-A14A-9A8D-05A3F4363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D08DAE-A4BB-574C-8546-4F9DE108F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277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43ABBF-F0E0-E14E-A8B7-692EE420A4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7CD818-C653-F849-BFEB-3AFEE7A5F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A6D96C-AD77-A349-B61B-2EEBB2226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F57DF3-CEF1-6E47-BE37-39004D8AB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86135-4584-F049-81C8-190751F69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060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90C20E-937C-4F41-816A-8653D870FA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0FD460-C5C8-524C-BDB9-FC41540E44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124B68-9CDA-C146-8352-074EAF127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27CF6B-527C-0245-81A6-C11A2B8E5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529513-EC31-7345-BBAF-70ABB0092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07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82E3A4-4764-7A4C-A571-08ED6E72A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BDA04-AA61-9D4C-91C5-3E186FAEF4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D59493-7236-224B-AB62-177D7D672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253AD-53D3-7345-B75E-80EB662B7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55C2D1-59D9-9246-BB2D-B9ECCB40C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893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37FB1-9EE6-D645-B99A-001B8DD25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F6FE8A-8CC8-284F-9387-6C03DF9A59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27CD46-6C3A-434F-A300-276F579C0E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109AE8-5AEA-4C4E-B843-B1BBE24D0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1F9740-7130-C44F-9771-828902029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16D43E-A382-DF4A-8427-B89A9EB0D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305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5320B-0169-2F4E-9B75-49221746E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D7B321-55DA-794A-BAE6-903061D010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6B0574-369B-354D-940F-9EF24576F3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BCEFCC-7468-1846-9294-3CB48BFC59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6E8903-18CF-4C4E-AD38-8AB311520F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9AA4C9-3510-FD4C-B121-4692AE6F0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4B188C-1E2E-9F4A-8BF1-440756710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8D8E20-37B3-3D47-B4A2-A931E4AFC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964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D5CA4E-E8AA-314F-A03B-C85373DBD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488525-0878-874F-B5A4-4AB96D3E5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70EBD6-247A-4644-BC10-A42546861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8FFF85-85BB-184E-86D7-138D6A38E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098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99483B-D349-DB45-B4D0-11E164CBE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090E87-23A3-6D42-8093-1F5B73C1E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8FCBC2-AF02-044E-8657-0ADAA70A9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90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FE796-8C96-C246-A192-937D333B2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9D8DE6-5E90-2044-A44F-1616131CE1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98B0C7-C674-2648-B203-75B35E59DF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C1EE4C-8655-D340-876D-D97353EDB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4D8C0-263A-0A48-BEC6-3772FC7F8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28C187-D392-FF4E-BFE5-A7F0559D5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998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DF516-FF8A-E243-9948-278EC79E3A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EB7A3C-8346-8940-9FBF-2EC1051577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B0FE9E-5D1B-3E48-86B5-C7B63053E9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9E6B54-B469-A948-9460-BAE8165B7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30DC2C-980F-9D46-A64C-E941D377F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E7C12D-A638-D044-A4F2-474014DAF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69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43C868-0360-3F4F-9A5F-095A89AF6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85B75C-EFE4-EE4F-AE26-7F5FA11AE9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9E8B0D-2E85-E448-9F4F-5C24869675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95F5D7-55BF-CE44-863A-8A5D5234E41B}" type="datetimeFigureOut">
              <a:rPr lang="en-US" smtClean="0"/>
              <a:t>9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7D7449-0576-B342-B86E-4DFC183B8C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A13821-8E22-EA4F-ADB1-85A874EC7B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B9F10-A151-A54C-8C45-7F457FA8D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116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5A7177B-F044-8441-A960-31696C0D67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1519" y="12833"/>
            <a:ext cx="4837591" cy="288276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030AC3A-0E42-614D-8CDE-A3CCDBD45D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22451"/>
            <a:ext cx="4837591" cy="288276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A1EC11E-277A-F947-AF77-C76605E3BE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1518" y="2862574"/>
            <a:ext cx="4837591" cy="28827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946289-9FFB-264B-94AA-8B200FFF3F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6000" y="2884876"/>
            <a:ext cx="4837591" cy="28827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37F1240-4068-5446-A83C-C4193ED725E9}"/>
              </a:ext>
            </a:extLst>
          </p:cNvPr>
          <p:cNvSpPr txBox="1"/>
          <p:nvPr/>
        </p:nvSpPr>
        <p:spPr>
          <a:xfrm>
            <a:off x="823169" y="-53203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D7C545B-9DFB-1E44-8E3F-A8F70066696F}"/>
              </a:ext>
            </a:extLst>
          </p:cNvPr>
          <p:cNvSpPr txBox="1"/>
          <p:nvPr/>
        </p:nvSpPr>
        <p:spPr>
          <a:xfrm>
            <a:off x="5889445" y="-53203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CE4D7BE-2A67-4D4A-BA69-2538737F5D98}"/>
              </a:ext>
            </a:extLst>
          </p:cNvPr>
          <p:cNvSpPr txBox="1"/>
          <p:nvPr/>
        </p:nvSpPr>
        <p:spPr>
          <a:xfrm>
            <a:off x="870722" y="2833104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EE2710B-0C4D-2848-905C-4F5F932EA4B8}"/>
              </a:ext>
            </a:extLst>
          </p:cNvPr>
          <p:cNvSpPr txBox="1"/>
          <p:nvPr/>
        </p:nvSpPr>
        <p:spPr>
          <a:xfrm>
            <a:off x="5936998" y="2833104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A8D20C2-0507-304D-9940-D2FE473A542A}"/>
              </a:ext>
            </a:extLst>
          </p:cNvPr>
          <p:cNvGrpSpPr/>
          <p:nvPr/>
        </p:nvGrpSpPr>
        <p:grpSpPr>
          <a:xfrm>
            <a:off x="3272794" y="5712262"/>
            <a:ext cx="6061166" cy="285125"/>
            <a:chOff x="2063931" y="6498693"/>
            <a:chExt cx="6061166" cy="285125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D9F330A-907E-9344-90EE-6A9E880FFCE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46449" y="6563443"/>
              <a:ext cx="279400" cy="1524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F7B653C-3988-3E4B-BD87-72CE521D9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60308" y="6589206"/>
              <a:ext cx="292100" cy="1397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4A67A99-F160-3941-8D85-A317ACF7D8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216022" y="6539778"/>
              <a:ext cx="292100" cy="2159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0631C26-2C3B-4C42-9F72-4D3DCE3EB668}"/>
                </a:ext>
              </a:extLst>
            </p:cNvPr>
            <p:cNvSpPr txBox="1"/>
            <p:nvPr/>
          </p:nvSpPr>
          <p:spPr>
            <a:xfrm>
              <a:off x="2487928" y="6498693"/>
              <a:ext cx="1396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ow risk (score 0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E230B30-8B3E-C248-89DF-C5D2AA8C2943}"/>
                </a:ext>
              </a:extLst>
            </p:cNvPr>
            <p:cNvSpPr txBox="1"/>
            <p:nvPr/>
          </p:nvSpPr>
          <p:spPr>
            <a:xfrm>
              <a:off x="6440312" y="6506819"/>
              <a:ext cx="15664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igh risk (score 2-3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3590AC-ABE5-904A-982D-19FACF4C1746}"/>
                </a:ext>
              </a:extLst>
            </p:cNvPr>
            <p:cNvSpPr txBox="1"/>
            <p:nvPr/>
          </p:nvSpPr>
          <p:spPr>
            <a:xfrm>
              <a:off x="4163016" y="6502463"/>
              <a:ext cx="19688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termediate risk (score 1)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74C6C083-8490-384F-888C-57B619E8C906}"/>
                </a:ext>
              </a:extLst>
            </p:cNvPr>
            <p:cNvSpPr/>
            <p:nvPr/>
          </p:nvSpPr>
          <p:spPr>
            <a:xfrm>
              <a:off x="2063931" y="6498693"/>
              <a:ext cx="6061166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2E41965C-0432-45E6-8181-C811B745D6AB}"/>
              </a:ext>
            </a:extLst>
          </p:cNvPr>
          <p:cNvSpPr txBox="1"/>
          <p:nvPr/>
        </p:nvSpPr>
        <p:spPr>
          <a:xfrm>
            <a:off x="4687667" y="2221039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&lt;0.00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B1CE489-0BDE-4E58-8FC5-4D8F07F53D18}"/>
              </a:ext>
            </a:extLst>
          </p:cNvPr>
          <p:cNvSpPr txBox="1"/>
          <p:nvPr/>
        </p:nvSpPr>
        <p:spPr>
          <a:xfrm>
            <a:off x="4687667" y="5075199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&lt;0.0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F83167-99DD-48FD-ACDD-2CDEC586B40B}"/>
              </a:ext>
            </a:extLst>
          </p:cNvPr>
          <p:cNvSpPr txBox="1"/>
          <p:nvPr/>
        </p:nvSpPr>
        <p:spPr>
          <a:xfrm>
            <a:off x="9709244" y="2217093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&lt;0.00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61D204F-F077-46D9-8034-60865FBD24D7}"/>
              </a:ext>
            </a:extLst>
          </p:cNvPr>
          <p:cNvSpPr txBox="1"/>
          <p:nvPr/>
        </p:nvSpPr>
        <p:spPr>
          <a:xfrm>
            <a:off x="9709244" y="5071066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&lt;0.00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9D95AC2-E760-5A46-B8D1-386A5BE2CEB6}"/>
              </a:ext>
            </a:extLst>
          </p:cNvPr>
          <p:cNvSpPr/>
          <p:nvPr/>
        </p:nvSpPr>
        <p:spPr>
          <a:xfrm>
            <a:off x="823169" y="6082902"/>
            <a:ext cx="1092809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Time to progression (TTP) over time in patients with cross-sectional imaging prior to progression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TTP is presented stratified by the Mayo 2018 SMM risk score at baseline (n=496) (A), and post-diagnosis landmarks of 1 year (n=343) (B), 3 years (n=208) (C), and 4 years (n= 161) (D). The risk score was re-assessed based on updated data at each time point. </a:t>
            </a:r>
          </a:p>
        </p:txBody>
      </p:sp>
    </p:spTree>
    <p:extLst>
      <p:ext uri="{BB962C8B-B14F-4D97-AF65-F5344CB8AC3E}">
        <p14:creationId xmlns:p14="http://schemas.microsoft.com/office/powerpoint/2010/main" val="2452143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5</Words>
  <Application>Microsoft Macintosh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ssa Visram</dc:creator>
  <cp:lastModifiedBy>Alissa Visram</cp:lastModifiedBy>
  <cp:revision>2</cp:revision>
  <dcterms:created xsi:type="dcterms:W3CDTF">2021-07-01T04:31:36Z</dcterms:created>
  <dcterms:modified xsi:type="dcterms:W3CDTF">2021-09-03T15:25:12Z</dcterms:modified>
</cp:coreProperties>
</file>